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  <p:sldId id="257" r:id="rId3"/>
    <p:sldId id="258" r:id="rId4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0"/>
    <p:restoredTop sz="96327"/>
  </p:normalViewPr>
  <p:slideViewPr>
    <p:cSldViewPr snapToGrid="0">
      <p:cViewPr varScale="1">
        <p:scale>
          <a:sx n="77" d="100"/>
          <a:sy n="77" d="100"/>
        </p:scale>
        <p:origin x="3072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D6F5F9-878E-DD42-943D-CAF3141A7B04}" type="datetimeFigureOut">
              <a:rPr lang="en-US" smtClean="0"/>
              <a:t>10/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105823-BCD2-194E-A3D2-60609E0E29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13732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D6F5F9-878E-DD42-943D-CAF3141A7B04}" type="datetimeFigureOut">
              <a:rPr lang="en-US" smtClean="0"/>
              <a:t>10/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105823-BCD2-194E-A3D2-60609E0E29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76548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D6F5F9-878E-DD42-943D-CAF3141A7B04}" type="datetimeFigureOut">
              <a:rPr lang="en-US" smtClean="0"/>
              <a:t>10/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105823-BCD2-194E-A3D2-60609E0E29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1094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D6F5F9-878E-DD42-943D-CAF3141A7B04}" type="datetimeFigureOut">
              <a:rPr lang="en-US" smtClean="0"/>
              <a:t>10/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105823-BCD2-194E-A3D2-60609E0E29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19161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D6F5F9-878E-DD42-943D-CAF3141A7B04}" type="datetimeFigureOut">
              <a:rPr lang="en-US" smtClean="0"/>
              <a:t>10/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105823-BCD2-194E-A3D2-60609E0E29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47190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D6F5F9-878E-DD42-943D-CAF3141A7B04}" type="datetimeFigureOut">
              <a:rPr lang="en-US" smtClean="0"/>
              <a:t>10/2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105823-BCD2-194E-A3D2-60609E0E29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71905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D6F5F9-878E-DD42-943D-CAF3141A7B04}" type="datetimeFigureOut">
              <a:rPr lang="en-US" smtClean="0"/>
              <a:t>10/2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105823-BCD2-194E-A3D2-60609E0E29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21554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D6F5F9-878E-DD42-943D-CAF3141A7B04}" type="datetimeFigureOut">
              <a:rPr lang="en-US" smtClean="0"/>
              <a:t>10/2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105823-BCD2-194E-A3D2-60609E0E29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39969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D6F5F9-878E-DD42-943D-CAF3141A7B04}" type="datetimeFigureOut">
              <a:rPr lang="en-US" smtClean="0"/>
              <a:t>10/2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105823-BCD2-194E-A3D2-60609E0E29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70081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D6F5F9-878E-DD42-943D-CAF3141A7B04}" type="datetimeFigureOut">
              <a:rPr lang="en-US" smtClean="0"/>
              <a:t>10/2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105823-BCD2-194E-A3D2-60609E0E29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64106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D6F5F9-878E-DD42-943D-CAF3141A7B04}" type="datetimeFigureOut">
              <a:rPr lang="en-US" smtClean="0"/>
              <a:t>10/2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105823-BCD2-194E-A3D2-60609E0E29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57811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D6F5F9-878E-DD42-943D-CAF3141A7B04}" type="datetimeFigureOut">
              <a:rPr lang="en-US" smtClean="0"/>
              <a:t>10/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105823-BCD2-194E-A3D2-60609E0E29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25207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.png"/><Relationship Id="rId5" Type="http://schemas.openxmlformats.org/officeDocument/2006/relationships/image" Target="../media/image6.png"/><Relationship Id="rId4" Type="http://schemas.openxmlformats.org/officeDocument/2006/relationships/image" Target="../media/image5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2.png"/><Relationship Id="rId5" Type="http://schemas.openxmlformats.org/officeDocument/2006/relationships/image" Target="../media/image11.png"/><Relationship Id="rId4" Type="http://schemas.openxmlformats.org/officeDocument/2006/relationships/image" Target="../media/image1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D259EFE9-35E3-69ED-27DB-6F52116734A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8769" y="154675"/>
            <a:ext cx="2828925" cy="3265452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D0D7DAC0-2992-36F2-5E53-040254E00B33}"/>
              </a:ext>
            </a:extLst>
          </p:cNvPr>
          <p:cNvSpPr txBox="1"/>
          <p:nvPr/>
        </p:nvSpPr>
        <p:spPr>
          <a:xfrm>
            <a:off x="157162" y="154675"/>
            <a:ext cx="26321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A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C9F6BC5A-D46E-6214-B155-418646E949B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429000" y="20564"/>
            <a:ext cx="2826938" cy="3533673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9FA86D22-75C5-3F95-5F54-134E024DD719}"/>
              </a:ext>
            </a:extLst>
          </p:cNvPr>
          <p:cNvSpPr txBox="1"/>
          <p:nvPr/>
        </p:nvSpPr>
        <p:spPr>
          <a:xfrm>
            <a:off x="3429000" y="154675"/>
            <a:ext cx="26321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B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D889079A-7490-4514-3021-ABD0643815AD}"/>
              </a:ext>
            </a:extLst>
          </p:cNvPr>
          <p:cNvSpPr txBox="1"/>
          <p:nvPr/>
        </p:nvSpPr>
        <p:spPr>
          <a:xfrm>
            <a:off x="288769" y="3628528"/>
            <a:ext cx="6067101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. Assessment of symptom redundancy and normality: (A)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ssessment of symptom redundancy using Unique Variable Analysis (UVA). Shown are the weighted topological overlaps (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TO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of the top twenty scoring variable pairs, as calculated by UVA.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TO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easures the extent to which variables in a network overlap, and variables with a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TO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&gt;0.25 are potentially redundant. Out of the three variable pairs with a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TO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&gt;0.25, nausea-vomiting was consolidated into a single latent variable because the pair exhibited conceptual redundancy and floor effects, as vomiting had the lowest average severity across all symptoms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ssessment of symptom severity distributions normality. Shapiro-Wilk test rejects a hypothesis of normality for all symptoms with p &lt; 0.00001.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1381047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F9441786-4583-8C2F-728F-6FC549288D29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6496" r="1382"/>
          <a:stretch/>
        </p:blipFill>
        <p:spPr>
          <a:xfrm>
            <a:off x="90285" y="453216"/>
            <a:ext cx="3228039" cy="2232957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66F2D3EB-5F87-4AB8-643A-6595D4C7D454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3446" t="1991" r="1909" b="2389"/>
          <a:stretch/>
        </p:blipFill>
        <p:spPr>
          <a:xfrm>
            <a:off x="3429000" y="453216"/>
            <a:ext cx="3228039" cy="2114665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E92FBD03-22DE-1C62-4B3B-8A8EDAF5808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0285" y="2961626"/>
            <a:ext cx="3228040" cy="1987683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5394642C-80AE-B793-8FB4-796C7766534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539676" y="2908049"/>
            <a:ext cx="3228039" cy="2041260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DB9F9CA8-482B-05C9-2973-0BD232E2C4D9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90284" y="5167316"/>
            <a:ext cx="3228039" cy="2126319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88C9B9DC-A58B-2A47-E977-CE66AD498D31}"/>
              </a:ext>
            </a:extLst>
          </p:cNvPr>
          <p:cNvSpPr txBox="1"/>
          <p:nvPr/>
        </p:nvSpPr>
        <p:spPr>
          <a:xfrm>
            <a:off x="69354" y="149187"/>
            <a:ext cx="26321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C9287DA0-EB5B-928F-1C24-650BDF468315}"/>
              </a:ext>
            </a:extLst>
          </p:cNvPr>
          <p:cNvSpPr txBox="1"/>
          <p:nvPr/>
        </p:nvSpPr>
        <p:spPr>
          <a:xfrm>
            <a:off x="3429000" y="149187"/>
            <a:ext cx="26321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B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C6A3602B-194C-CBD7-B16C-BB2AB10B6ECC}"/>
              </a:ext>
            </a:extLst>
          </p:cNvPr>
          <p:cNvSpPr txBox="1"/>
          <p:nvPr/>
        </p:nvSpPr>
        <p:spPr>
          <a:xfrm>
            <a:off x="65665" y="2652955"/>
            <a:ext cx="26321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C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8E481715-E21B-23B4-958E-D8B719E6F14E}"/>
              </a:ext>
            </a:extLst>
          </p:cNvPr>
          <p:cNvSpPr txBox="1"/>
          <p:nvPr/>
        </p:nvSpPr>
        <p:spPr>
          <a:xfrm>
            <a:off x="3429000" y="2651946"/>
            <a:ext cx="26321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D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EC9F45D1-6389-B1F7-0410-00F97575D42D}"/>
              </a:ext>
            </a:extLst>
          </p:cNvPr>
          <p:cNvSpPr txBox="1"/>
          <p:nvPr/>
        </p:nvSpPr>
        <p:spPr>
          <a:xfrm>
            <a:off x="72308" y="4983753"/>
            <a:ext cx="26321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E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C48C9396-6665-2ACA-A267-D0A33F656FA6}"/>
              </a:ext>
            </a:extLst>
          </p:cNvPr>
          <p:cNvSpPr txBox="1"/>
          <p:nvPr/>
        </p:nvSpPr>
        <p:spPr>
          <a:xfrm>
            <a:off x="203914" y="7511642"/>
            <a:ext cx="6283971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. Networks for patient subgroups 1 through 5: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gularized </a:t>
            </a:r>
            <a:r>
              <a:rPr lang="en-US" sz="1200" b="0" i="0" dirty="0">
                <a:solidFill>
                  <a:srgbClr val="2A2A2A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Gaussian Graphical Models (GGMs) were generated from the symptom severity data from each patient subgroup. The </a:t>
            </a:r>
            <a:r>
              <a:rPr lang="en-US" sz="1200" b="0" i="0" dirty="0" err="1">
                <a:solidFill>
                  <a:srgbClr val="2A2A2A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walktrap</a:t>
            </a:r>
            <a:r>
              <a:rPr lang="en-US" sz="1200" b="0" i="0" dirty="0">
                <a:solidFill>
                  <a:srgbClr val="2A2A2A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algorithm was used to identify symptom clusters within each subgroup. A GGM could not be generated for patient subgroup 6 because symptom severity was very low across all patients.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5755E75C-6670-3361-09B3-1F0BDA830A8A}"/>
              </a:ext>
            </a:extLst>
          </p:cNvPr>
          <p:cNvSpPr txBox="1"/>
          <p:nvPr/>
        </p:nvSpPr>
        <p:spPr>
          <a:xfrm>
            <a:off x="542925" y="149187"/>
            <a:ext cx="50366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PC1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CCF980C3-B6F6-6C2D-2B62-C88835749EAF}"/>
              </a:ext>
            </a:extLst>
          </p:cNvPr>
          <p:cNvSpPr txBox="1"/>
          <p:nvPr/>
        </p:nvSpPr>
        <p:spPr>
          <a:xfrm>
            <a:off x="3802890" y="149187"/>
            <a:ext cx="50366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PC2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F86F30F6-48AA-8932-BA7B-178E2BC208E1}"/>
              </a:ext>
            </a:extLst>
          </p:cNvPr>
          <p:cNvSpPr txBox="1"/>
          <p:nvPr/>
        </p:nvSpPr>
        <p:spPr>
          <a:xfrm>
            <a:off x="542925" y="2729717"/>
            <a:ext cx="50366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PC3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B65543EF-654E-58C3-B74E-8AA1FE0082F7}"/>
              </a:ext>
            </a:extLst>
          </p:cNvPr>
          <p:cNvSpPr txBox="1"/>
          <p:nvPr/>
        </p:nvSpPr>
        <p:spPr>
          <a:xfrm>
            <a:off x="3802889" y="2729717"/>
            <a:ext cx="50366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PC4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C6034A93-6749-C8F7-AEDC-7AC553484184}"/>
              </a:ext>
            </a:extLst>
          </p:cNvPr>
          <p:cNvSpPr txBox="1"/>
          <p:nvPr/>
        </p:nvSpPr>
        <p:spPr>
          <a:xfrm>
            <a:off x="542925" y="4974636"/>
            <a:ext cx="50366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PC5</a:t>
            </a:r>
          </a:p>
        </p:txBody>
      </p:sp>
    </p:spTree>
    <p:extLst>
      <p:ext uri="{BB962C8B-B14F-4D97-AF65-F5344CB8AC3E}">
        <p14:creationId xmlns:p14="http://schemas.microsoft.com/office/powerpoint/2010/main" val="360754281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9A146019-DFBF-AB48-0F7C-44E3E6F85434}"/>
              </a:ext>
            </a:extLst>
          </p:cNvPr>
          <p:cNvSpPr txBox="1"/>
          <p:nvPr/>
        </p:nvSpPr>
        <p:spPr>
          <a:xfrm>
            <a:off x="69354" y="149187"/>
            <a:ext cx="26321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A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F5DA68B4-1DAE-B8EA-6FC4-893BE3010305}"/>
              </a:ext>
            </a:extLst>
          </p:cNvPr>
          <p:cNvSpPr txBox="1"/>
          <p:nvPr/>
        </p:nvSpPr>
        <p:spPr>
          <a:xfrm>
            <a:off x="3429000" y="149187"/>
            <a:ext cx="26321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B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75F68136-23DA-EF6B-74C0-01657AF398F5}"/>
              </a:ext>
            </a:extLst>
          </p:cNvPr>
          <p:cNvSpPr txBox="1"/>
          <p:nvPr/>
        </p:nvSpPr>
        <p:spPr>
          <a:xfrm>
            <a:off x="65665" y="2495790"/>
            <a:ext cx="26321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C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536EAA0B-413A-580C-0EFB-47340A729841}"/>
              </a:ext>
            </a:extLst>
          </p:cNvPr>
          <p:cNvSpPr txBox="1"/>
          <p:nvPr/>
        </p:nvSpPr>
        <p:spPr>
          <a:xfrm>
            <a:off x="3429000" y="2494781"/>
            <a:ext cx="26321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D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20E6906D-18F5-5954-DFE5-953A97A2E27B}"/>
              </a:ext>
            </a:extLst>
          </p:cNvPr>
          <p:cNvSpPr txBox="1"/>
          <p:nvPr/>
        </p:nvSpPr>
        <p:spPr>
          <a:xfrm>
            <a:off x="72308" y="4898005"/>
            <a:ext cx="26321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E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6B3E64D1-0966-E92E-AF1E-02CFF822B6B3}"/>
              </a:ext>
            </a:extLst>
          </p:cNvPr>
          <p:cNvSpPr txBox="1"/>
          <p:nvPr/>
        </p:nvSpPr>
        <p:spPr>
          <a:xfrm>
            <a:off x="65665" y="7410656"/>
            <a:ext cx="665408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3. Centrality measurements for patient subgroups 1 through 5: </a:t>
            </a:r>
            <a:r>
              <a:rPr lang="en-US" sz="1200" b="0" i="0" dirty="0">
                <a:solidFill>
                  <a:srgbClr val="2A2A2A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Z-scored strength, closeness, and betweenness centrality for all symptoms in each patient subgroup.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3FD79609-0DF3-54BD-527A-CD4E176F91BB}"/>
              </a:ext>
            </a:extLst>
          </p:cNvPr>
          <p:cNvSpPr txBox="1"/>
          <p:nvPr/>
        </p:nvSpPr>
        <p:spPr>
          <a:xfrm>
            <a:off x="335522" y="149187"/>
            <a:ext cx="50366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PC1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DF8CDA23-BCAD-6BCC-50EA-785B5CA39952}"/>
              </a:ext>
            </a:extLst>
          </p:cNvPr>
          <p:cNvSpPr txBox="1"/>
          <p:nvPr/>
        </p:nvSpPr>
        <p:spPr>
          <a:xfrm>
            <a:off x="3761568" y="146189"/>
            <a:ext cx="50366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PC2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739DBEB3-16A0-950B-A527-38734724F3B9}"/>
              </a:ext>
            </a:extLst>
          </p:cNvPr>
          <p:cNvSpPr txBox="1"/>
          <p:nvPr/>
        </p:nvSpPr>
        <p:spPr>
          <a:xfrm>
            <a:off x="328879" y="2503109"/>
            <a:ext cx="50366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PC3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2C3B92B6-42C0-01F5-694F-2F625DB99F13}"/>
              </a:ext>
            </a:extLst>
          </p:cNvPr>
          <p:cNvSpPr txBox="1"/>
          <p:nvPr/>
        </p:nvSpPr>
        <p:spPr>
          <a:xfrm>
            <a:off x="3757879" y="2503109"/>
            <a:ext cx="50366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PC4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FDD6B8C6-CC4F-50C6-5179-419BA1182725}"/>
              </a:ext>
            </a:extLst>
          </p:cNvPr>
          <p:cNvSpPr txBox="1"/>
          <p:nvPr/>
        </p:nvSpPr>
        <p:spPr>
          <a:xfrm>
            <a:off x="327237" y="4893251"/>
            <a:ext cx="50366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PC5</a:t>
            </a:r>
          </a:p>
        </p:txBody>
      </p:sp>
      <p:pic>
        <p:nvPicPr>
          <p:cNvPr id="18" name="Picture 17">
            <a:extLst>
              <a:ext uri="{FF2B5EF4-FFF2-40B4-BE49-F238E27FC236}">
                <a16:creationId xmlns:a16="http://schemas.microsoft.com/office/drawing/2014/main" id="{97A14740-9FBD-73B2-1A1D-3E2F8929629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408393"/>
            <a:ext cx="3435643" cy="2123207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0666B14D-E229-4878-606A-B4FF04C67D0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435643" y="408393"/>
            <a:ext cx="3429000" cy="2119102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4B24E885-023A-FDC9-1032-A8159F89069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0" y="2829793"/>
            <a:ext cx="3435643" cy="2123207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2660DE3A-B246-9E1A-6915-032A689C923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435643" y="2774149"/>
            <a:ext cx="3429000" cy="2119102"/>
          </a:xfrm>
          <a:prstGeom prst="rect">
            <a:avLst/>
          </a:prstGeom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E0357127-B986-FBAE-3BC4-C3F12D755B83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643" y="5164291"/>
            <a:ext cx="3429000" cy="211910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328566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274</TotalTime>
  <Words>251</Words>
  <Application>Microsoft Office PowerPoint</Application>
  <PresentationFormat>A4 Paper (210x297 mm)</PresentationFormat>
  <Paragraphs>25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randon Hwa-Lin Bergsneider</dc:creator>
  <cp:lastModifiedBy>Miaskowski, Christine</cp:lastModifiedBy>
  <cp:revision>31</cp:revision>
  <dcterms:created xsi:type="dcterms:W3CDTF">2023-05-21T18:20:04Z</dcterms:created>
  <dcterms:modified xsi:type="dcterms:W3CDTF">2023-10-02T14:57:18Z</dcterms:modified>
</cp:coreProperties>
</file>